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2" r:id="rId3"/>
    <p:sldId id="263" r:id="rId4"/>
    <p:sldId id="267" r:id="rId5"/>
    <p:sldId id="259" r:id="rId6"/>
    <p:sldId id="265" r:id="rId7"/>
    <p:sldId id="256" r:id="rId8"/>
    <p:sldId id="266" r:id="rId9"/>
    <p:sldId id="257" r:id="rId10"/>
    <p:sldId id="258" r:id="rId11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793" autoAdjust="0"/>
    <p:restoredTop sz="96774" autoAdjust="0"/>
  </p:normalViewPr>
  <p:slideViewPr>
    <p:cSldViewPr>
      <p:cViewPr varScale="1">
        <p:scale>
          <a:sx n="112" d="100"/>
          <a:sy n="112" d="100"/>
        </p:scale>
        <p:origin x="-1662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3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00001F-9272-439B-BB9C-32807583FE63}" type="datetimeFigureOut">
              <a:rPr lang="ko-KR" altLang="en-US" smtClean="0"/>
              <a:pPr/>
              <a:t>2015-11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EC5B8-6725-4A3C-89E4-347696A95C2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00001F-9272-439B-BB9C-32807583FE63}" type="datetimeFigureOut">
              <a:rPr lang="ko-KR" altLang="en-US" smtClean="0"/>
              <a:pPr/>
              <a:t>2015-11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EC5B8-6725-4A3C-89E4-347696A95C2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00001F-9272-439B-BB9C-32807583FE63}" type="datetimeFigureOut">
              <a:rPr lang="ko-KR" altLang="en-US" smtClean="0"/>
              <a:pPr/>
              <a:t>2015-11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EC5B8-6725-4A3C-89E4-347696A95C2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00001F-9272-439B-BB9C-32807583FE63}" type="datetimeFigureOut">
              <a:rPr lang="ko-KR" altLang="en-US" smtClean="0"/>
              <a:pPr/>
              <a:t>2015-11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EC5B8-6725-4A3C-89E4-347696A95C2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00001F-9272-439B-BB9C-32807583FE63}" type="datetimeFigureOut">
              <a:rPr lang="ko-KR" altLang="en-US" smtClean="0"/>
              <a:pPr/>
              <a:t>2015-11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EC5B8-6725-4A3C-89E4-347696A95C2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00001F-9272-439B-BB9C-32807583FE63}" type="datetimeFigureOut">
              <a:rPr lang="ko-KR" altLang="en-US" smtClean="0"/>
              <a:pPr/>
              <a:t>2015-11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EC5B8-6725-4A3C-89E4-347696A95C2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00001F-9272-439B-BB9C-32807583FE63}" type="datetimeFigureOut">
              <a:rPr lang="ko-KR" altLang="en-US" smtClean="0"/>
              <a:pPr/>
              <a:t>2015-11-2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EC5B8-6725-4A3C-89E4-347696A95C2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00001F-9272-439B-BB9C-32807583FE63}" type="datetimeFigureOut">
              <a:rPr lang="ko-KR" altLang="en-US" smtClean="0"/>
              <a:pPr/>
              <a:t>2015-11-2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EC5B8-6725-4A3C-89E4-347696A95C2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00001F-9272-439B-BB9C-32807583FE63}" type="datetimeFigureOut">
              <a:rPr lang="ko-KR" altLang="en-US" smtClean="0"/>
              <a:pPr/>
              <a:t>2015-11-2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EC5B8-6725-4A3C-89E4-347696A95C2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00001F-9272-439B-BB9C-32807583FE63}" type="datetimeFigureOut">
              <a:rPr lang="ko-KR" altLang="en-US" smtClean="0"/>
              <a:pPr/>
              <a:t>2015-11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EC5B8-6725-4A3C-89E4-347696A95C2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00001F-9272-439B-BB9C-32807583FE63}" type="datetimeFigureOut">
              <a:rPr lang="ko-KR" altLang="en-US" smtClean="0"/>
              <a:pPr/>
              <a:t>2015-11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EC5B8-6725-4A3C-89E4-347696A95C2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00001F-9272-439B-BB9C-32807583FE63}" type="datetimeFigureOut">
              <a:rPr lang="ko-KR" altLang="en-US" smtClean="0"/>
              <a:pPr/>
              <a:t>2015-11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1EC5B8-6725-4A3C-89E4-347696A95C2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3.wmf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2" cstate="print"/>
          <a:srcRect b="8760"/>
          <a:stretch>
            <a:fillRect/>
          </a:stretch>
        </p:blipFill>
        <p:spPr bwMode="auto">
          <a:xfrm>
            <a:off x="1259632" y="3861048"/>
            <a:ext cx="7128792" cy="23042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 cstate="print"/>
          <a:srcRect b="8436"/>
          <a:stretch>
            <a:fillRect/>
          </a:stretch>
        </p:blipFill>
        <p:spPr bwMode="auto">
          <a:xfrm>
            <a:off x="1331640" y="836712"/>
            <a:ext cx="6984776" cy="2808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extBox 4"/>
          <p:cNvSpPr txBox="1"/>
          <p:nvPr/>
        </p:nvSpPr>
        <p:spPr>
          <a:xfrm>
            <a:off x="395536" y="411922"/>
            <a:ext cx="8424936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500" b="1" dirty="0" smtClean="0">
                <a:latin typeface="Times New Roman" pitchFamily="18" charset="0"/>
                <a:cs typeface="Times New Roman" pitchFamily="18" charset="0"/>
              </a:rPr>
              <a:t>Figure S1. </a:t>
            </a:r>
            <a:r>
              <a:rPr lang="en-US" altLang="ko-KR" sz="1500" dirty="0" smtClean="0">
                <a:latin typeface="Times New Roman" pitchFamily="18" charset="0"/>
                <a:cs typeface="Times New Roman" pitchFamily="18" charset="0"/>
              </a:rPr>
              <a:t>MS and MS/MS spectra of </a:t>
            </a:r>
            <a:r>
              <a:rPr lang="en-US" altLang="ko-KR" sz="1500" i="1" dirty="0" smtClean="0">
                <a:latin typeface="Times New Roman" pitchFamily="18" charset="0"/>
                <a:cs typeface="Times New Roman" pitchFamily="18" charset="0"/>
              </a:rPr>
              <a:t>in vitro </a:t>
            </a:r>
            <a:r>
              <a:rPr lang="en-US" altLang="ko-KR" sz="1500" dirty="0" smtClean="0">
                <a:latin typeface="Times New Roman" pitchFamily="18" charset="0"/>
                <a:cs typeface="Times New Roman" pitchFamily="18" charset="0"/>
              </a:rPr>
              <a:t>laccase-catalyzed polymerization of 2,7-DHN. (A) MS spectrum of the enzymatic reaction; (B) Collision induced dissociation (CID) MS/MS of  317 m/z; (C) CID MS/MS of 475 m/z</a:t>
            </a:r>
            <a:endParaRPr lang="ko-KR" altLang="en-US" sz="15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187624" y="6232956"/>
            <a:ext cx="7272810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 dirty="0" smtClean="0"/>
              <a:t>m/z</a:t>
            </a:r>
            <a:endParaRPr lang="ko-KR" altLang="en-US" sz="13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1475656" y="1417132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/>
              <a:t>(A)</a:t>
            </a:r>
            <a:endParaRPr lang="ko-KR" altLang="en-US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1475656" y="3933056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/>
              <a:t>(B)</a:t>
            </a:r>
            <a:endParaRPr lang="ko-KR" altLang="en-US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6804248" y="3959478"/>
            <a:ext cx="7920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b="1" dirty="0" smtClean="0"/>
              <a:t>317.0</a:t>
            </a:r>
            <a:endParaRPr lang="ko-KR" altLang="en-US" sz="11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1043608" y="5733256"/>
            <a:ext cx="7920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dirty="0" smtClean="0"/>
              <a:t>130.1</a:t>
            </a:r>
            <a:endParaRPr lang="ko-KR" altLang="en-US" sz="1100" dirty="0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oup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36267585"/>
              </p:ext>
            </p:extLst>
          </p:nvPr>
        </p:nvGraphicFramePr>
        <p:xfrm>
          <a:off x="467544" y="1268760"/>
          <a:ext cx="6408712" cy="2016225"/>
        </p:xfrm>
        <a:graphic>
          <a:graphicData uri="http://schemas.openxmlformats.org/drawingml/2006/table">
            <a:tbl>
              <a:tblPr/>
              <a:tblGrid>
                <a:gridCol w="4203669"/>
                <a:gridCol w="2205043"/>
              </a:tblGrid>
              <a:tr h="40324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ko-KR" altLang="en-US" sz="14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맑은 고딕"/>
                        <a:cs typeface="맑은 고딕"/>
                      </a:endParaRPr>
                    </a:p>
                  </a:txBody>
                  <a:tcPr marL="90000" marR="90000" marT="46800" marB="46800" anchor="ctr" horzOverflow="overflow">
                    <a:lnL cap="flat"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ko-KR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맑은 고딕"/>
                          <a:cs typeface="맑은 고딕"/>
                        </a:rPr>
                        <a:t>Contact angle</a:t>
                      </a: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 cap="flat"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0324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ko-KR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맑은 고딕"/>
                          <a:cs typeface="맑은 고딕"/>
                        </a:rPr>
                        <a:t>Initial coating (4A-Left)</a:t>
                      </a:r>
                    </a:p>
                  </a:txBody>
                  <a:tcPr marL="90000" marR="90000" marT="46800" marB="46800" anchor="ctr" horzOverflow="overflow">
                    <a:lnL cap="flat"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ko-KR" sz="14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66.4 ± 1.8</a:t>
                      </a: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 cap="flat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0324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ko-KR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맑은 고딕"/>
                          <a:cs typeface="맑은 고딕"/>
                        </a:rPr>
                        <a:t>BSA post-immobilization (4A-Right)</a:t>
                      </a:r>
                    </a:p>
                  </a:txBody>
                  <a:tcPr marL="90000" marR="90000" marT="46800" marB="4680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ko-KR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81.4 ± 2.8</a:t>
                      </a: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0324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ko-KR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맑은 고딕"/>
                          <a:cs typeface="맑은 고딕"/>
                        </a:rPr>
                        <a:t>Precursor-immobilization (4D-Left)</a:t>
                      </a:r>
                    </a:p>
                  </a:txBody>
                  <a:tcPr marL="90000" marR="90000" marT="46800" marB="46800" anchor="ctr" horzOverflow="overflow">
                    <a:lnL cap="flat"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ko-KR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59.5 ± 2.1</a:t>
                      </a: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 cap="flat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0324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ko-KR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맑은 고딕"/>
                          <a:cs typeface="맑은 고딕"/>
                        </a:rPr>
                        <a:t>After Silicification (4D-Right)</a:t>
                      </a:r>
                    </a:p>
                  </a:txBody>
                  <a:tcPr marL="90000" marR="90000" marT="46800" marB="46800" anchor="ctr"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ko-KR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49.8 ± 3.8</a:t>
                      </a: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23528" y="583132"/>
            <a:ext cx="856895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Table S4. 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Water contact angle of  post- or co-immobilized PET films shown in Figure 4. Average and standard deviations of six-measurement were shown.  </a:t>
            </a:r>
            <a:endParaRPr lang="ko-KR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/>
          <a:srcRect r="1961" b="5501"/>
          <a:stretch>
            <a:fillRect/>
          </a:stretch>
        </p:blipFill>
        <p:spPr bwMode="auto">
          <a:xfrm>
            <a:off x="1331640" y="764704"/>
            <a:ext cx="7200800" cy="331236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TextBox 7"/>
          <p:cNvSpPr txBox="1"/>
          <p:nvPr/>
        </p:nvSpPr>
        <p:spPr>
          <a:xfrm>
            <a:off x="1475656" y="611396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/>
              <a:t>(C)</a:t>
            </a:r>
            <a:endParaRPr lang="ko-KR" altLang="en-US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1331640" y="4216732"/>
            <a:ext cx="7344816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 dirty="0" smtClean="0"/>
              <a:t>m/z</a:t>
            </a:r>
            <a:endParaRPr lang="ko-KR" altLang="en-US" sz="1300" b="1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23528" y="332656"/>
            <a:ext cx="8424936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500" b="1" dirty="0" smtClean="0">
                <a:latin typeface="Times New Roman" pitchFamily="18" charset="0"/>
                <a:cs typeface="Times New Roman" pitchFamily="18" charset="0"/>
              </a:rPr>
              <a:t>Figure S2. </a:t>
            </a:r>
            <a:r>
              <a:rPr lang="en-US" altLang="ko-KR" sz="1500" dirty="0" smtClean="0">
                <a:latin typeface="Times New Roman" pitchFamily="18" charset="0"/>
                <a:cs typeface="Times New Roman" pitchFamily="18" charset="0"/>
              </a:rPr>
              <a:t>H</a:t>
            </a:r>
            <a:r>
              <a:rPr lang="en-US" altLang="ko-KR" sz="1500" baseline="30000" dirty="0" smtClean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US" altLang="ko-KR" sz="1500" dirty="0" smtClean="0">
                <a:latin typeface="Times New Roman" pitchFamily="18" charset="0"/>
                <a:cs typeface="Times New Roman" pitchFamily="18" charset="0"/>
              </a:rPr>
              <a:t> NMR spectroscopic analysis of  two major intermediates during 2,7-DHN polymerization.</a:t>
            </a:r>
            <a:endParaRPr lang="ko-KR" altLang="en-US" sz="15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23529" y="980729"/>
            <a:ext cx="5544616" cy="2592288"/>
          </a:xfrm>
          <a:prstGeom prst="rect">
            <a:avLst/>
          </a:prstGeom>
          <a:noFill/>
          <a:ln w="9525">
            <a:solidFill>
              <a:schemeClr val="accent1"/>
            </a:solidFill>
            <a:miter lim="800000"/>
            <a:headEnd/>
            <a:tailEnd/>
          </a:ln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5940151" y="980729"/>
            <a:ext cx="2808313" cy="2592288"/>
          </a:xfrm>
          <a:prstGeom prst="rect">
            <a:avLst/>
          </a:prstGeom>
          <a:noFill/>
          <a:ln w="9525">
            <a:solidFill>
              <a:schemeClr val="accent1"/>
            </a:solidFill>
            <a:miter lim="800000"/>
            <a:headEnd/>
            <a:tailEnd/>
          </a:ln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23528" y="3645026"/>
            <a:ext cx="5544616" cy="2592288"/>
          </a:xfrm>
          <a:prstGeom prst="rect">
            <a:avLst/>
          </a:prstGeom>
          <a:noFill/>
          <a:ln w="9525">
            <a:solidFill>
              <a:schemeClr val="accent1"/>
            </a:solidFill>
            <a:miter lim="800000"/>
            <a:headEnd/>
            <a:tailEnd/>
          </a:ln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5940152" y="3645026"/>
            <a:ext cx="2808311" cy="2592288"/>
          </a:xfrm>
          <a:prstGeom prst="rect">
            <a:avLst/>
          </a:prstGeom>
          <a:noFill/>
          <a:ln w="9525">
            <a:solidFill>
              <a:schemeClr val="accent1"/>
            </a:solidFill>
            <a:miter lim="800000"/>
            <a:headEnd/>
            <a:tailEnd/>
          </a:ln>
        </p:spPr>
      </p:pic>
      <p:sp>
        <p:nvSpPr>
          <p:cNvPr id="7" name="TextBox 6"/>
          <p:cNvSpPr txBox="1"/>
          <p:nvPr/>
        </p:nvSpPr>
        <p:spPr>
          <a:xfrm>
            <a:off x="7812360" y="980728"/>
            <a:ext cx="9361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ak 1</a:t>
            </a:r>
            <a:endParaRPr lang="ko-KR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7812359" y="3645026"/>
            <a:ext cx="9361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ak 2</a:t>
            </a:r>
            <a:endParaRPr lang="ko-KR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0948" y="2190725"/>
            <a:ext cx="3695700" cy="3038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1" name="Picture 5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" r="20031" b="28517"/>
          <a:stretch/>
        </p:blipFill>
        <p:spPr bwMode="auto">
          <a:xfrm>
            <a:off x="4681388" y="2190725"/>
            <a:ext cx="3707036" cy="30298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323528" y="1233627"/>
            <a:ext cx="8424936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500" b="1" dirty="0" smtClean="0">
                <a:latin typeface="Times New Roman" pitchFamily="18" charset="0"/>
                <a:cs typeface="Times New Roman" pitchFamily="18" charset="0"/>
              </a:rPr>
              <a:t>Figure S3. </a:t>
            </a:r>
            <a:r>
              <a:rPr lang="en-US" altLang="ko-KR" sz="1500" dirty="0" smtClean="0">
                <a:latin typeface="Times New Roman" pitchFamily="18" charset="0"/>
                <a:cs typeface="Times New Roman" pitchFamily="18" charset="0"/>
              </a:rPr>
              <a:t>SEM image of 2,7-DHN-coated polystyrene plastic surfaces. (a) untreated; (b) treated.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864964" y="2377435"/>
            <a:ext cx="163182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8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ko-KR" altLang="en-US" sz="28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753396" y="2304901"/>
            <a:ext cx="163182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8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ko-KR" altLang="en-US" sz="28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직사각형 1"/>
          <p:cNvSpPr/>
          <p:nvPr/>
        </p:nvSpPr>
        <p:spPr>
          <a:xfrm>
            <a:off x="3455876" y="4927029"/>
            <a:ext cx="288032" cy="1440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bg1"/>
              </a:solidFill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3815916" y="4835276"/>
            <a:ext cx="6120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r>
              <a:rPr lang="el-GR" altLang="ko-KR" sz="1400" b="1" dirty="0" smtClean="0">
                <a:solidFill>
                  <a:schemeClr val="bg1"/>
                </a:solidFill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μ</a:t>
            </a:r>
            <a:r>
              <a:rPr lang="en-US" altLang="ko-KR" sz="1400" b="1" dirty="0" smtClean="0">
                <a:solidFill>
                  <a:schemeClr val="bg1"/>
                </a:solidFill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m</a:t>
            </a:r>
            <a:endParaRPr lang="ko-KR" altLang="en-US" sz="14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7416316" y="4927029"/>
            <a:ext cx="288032" cy="1440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bg1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7776356" y="4835276"/>
            <a:ext cx="6120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r>
              <a:rPr lang="el-GR" altLang="ko-KR" sz="1400" b="1" dirty="0" smtClean="0">
                <a:solidFill>
                  <a:schemeClr val="bg1"/>
                </a:solidFill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μ</a:t>
            </a:r>
            <a:r>
              <a:rPr lang="en-US" altLang="ko-KR" sz="1400" b="1" dirty="0" smtClean="0">
                <a:solidFill>
                  <a:schemeClr val="bg1"/>
                </a:solidFill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m</a:t>
            </a:r>
            <a:endParaRPr lang="ko-KR" altLang="en-US" sz="14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5041460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395536" y="915978"/>
            <a:ext cx="8424936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500" b="1" dirty="0" smtClean="0">
                <a:latin typeface="Times New Roman" pitchFamily="18" charset="0"/>
                <a:cs typeface="Times New Roman" pitchFamily="18" charset="0"/>
              </a:rPr>
              <a:t>Figure S4. </a:t>
            </a:r>
            <a:r>
              <a:rPr lang="en-US" altLang="ko-KR" sz="1500" dirty="0" smtClean="0">
                <a:latin typeface="Times New Roman" pitchFamily="18" charset="0"/>
                <a:cs typeface="Times New Roman" pitchFamily="18" charset="0"/>
              </a:rPr>
              <a:t>AFM image of 2,7-DHN coated PET film for coating thickness measurement. Half region of the coated PET was soaked in 1N </a:t>
            </a:r>
            <a:r>
              <a:rPr lang="en-US" altLang="ko-KR" sz="1500" dirty="0" err="1" smtClean="0">
                <a:latin typeface="Times New Roman" pitchFamily="18" charset="0"/>
                <a:cs typeface="Times New Roman" pitchFamily="18" charset="0"/>
              </a:rPr>
              <a:t>NaOH</a:t>
            </a:r>
            <a:r>
              <a:rPr lang="en-US" altLang="ko-KR" sz="1500" dirty="0" smtClean="0">
                <a:latin typeface="Times New Roman" pitchFamily="18" charset="0"/>
                <a:cs typeface="Times New Roman" pitchFamily="18" charset="0"/>
              </a:rPr>
              <a:t> for 10 seconds, thus making the DHN layer totally detached. The height difference between the detached and the coated PET surfaces was monitored through AFM scanning.     </a:t>
            </a:r>
            <a:endParaRPr lang="ko-KR" altLang="en-US" sz="15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239817" y="2492896"/>
            <a:ext cx="3240360" cy="2808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/>
          <a:srcRect l="-7752" t="2326" r="33333"/>
          <a:stretch>
            <a:fillRect/>
          </a:stretch>
        </p:blipFill>
        <p:spPr bwMode="auto">
          <a:xfrm flipH="1">
            <a:off x="929964" y="2411122"/>
            <a:ext cx="197510" cy="211623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 cstate="print"/>
          <a:srcRect t="-2217"/>
          <a:stretch>
            <a:fillRect/>
          </a:stretch>
        </p:blipFill>
        <p:spPr bwMode="auto">
          <a:xfrm>
            <a:off x="1310461" y="2348880"/>
            <a:ext cx="2912633" cy="286976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2" name="TextBox 11"/>
          <p:cNvSpPr txBox="1"/>
          <p:nvPr/>
        </p:nvSpPr>
        <p:spPr>
          <a:xfrm>
            <a:off x="1249466" y="5336506"/>
            <a:ext cx="1219900" cy="2527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00" dirty="0" smtClean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3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591356" y="5336506"/>
            <a:ext cx="1219900" cy="2527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00" dirty="0" smtClean="0">
                <a:latin typeface="Times New Roman" pitchFamily="18" charset="0"/>
                <a:cs typeface="Times New Roman" pitchFamily="18" charset="0"/>
              </a:rPr>
              <a:t>2.5</a:t>
            </a:r>
            <a:endParaRPr lang="ko-KR" altLang="en-US" sz="13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055237" y="5336506"/>
            <a:ext cx="1219900" cy="2527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00" dirty="0" smtClean="0">
                <a:latin typeface="Times New Roman" pitchFamily="18" charset="0"/>
                <a:cs typeface="Times New Roman" pitchFamily="18" charset="0"/>
              </a:rPr>
              <a:t>5</a:t>
            </a:r>
            <a:endParaRPr lang="ko-KR" altLang="en-US" sz="13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299217" y="2411122"/>
            <a:ext cx="1219900" cy="2527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00" dirty="0" smtClean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3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299217" y="3652201"/>
            <a:ext cx="1219900" cy="2527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00" dirty="0" smtClean="0">
                <a:latin typeface="Times New Roman" pitchFamily="18" charset="0"/>
                <a:cs typeface="Times New Roman" pitchFamily="18" charset="0"/>
              </a:rPr>
              <a:t>2.5</a:t>
            </a:r>
            <a:endParaRPr lang="ko-KR" altLang="en-US" sz="13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4299217" y="5025295"/>
            <a:ext cx="1219900" cy="2527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00" dirty="0" smtClean="0">
                <a:latin typeface="Times New Roman" pitchFamily="18" charset="0"/>
                <a:cs typeface="Times New Roman" pitchFamily="18" charset="0"/>
              </a:rPr>
              <a:t>5</a:t>
            </a:r>
            <a:endParaRPr lang="ko-KR" altLang="en-US" sz="13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360212" y="5336506"/>
            <a:ext cx="1219900" cy="2527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300" dirty="0" smtClean="0">
                <a:latin typeface="Times New Roman" pitchFamily="18" charset="0"/>
                <a:cs typeface="Times New Roman" pitchFamily="18" charset="0"/>
              </a:rPr>
              <a:t>μ</a:t>
            </a:r>
            <a:r>
              <a:rPr lang="en-US" altLang="ko-KR" sz="1300" dirty="0" smtClean="0">
                <a:latin typeface="Times New Roman" pitchFamily="18" charset="0"/>
                <a:cs typeface="Times New Roman" pitchFamily="18" charset="0"/>
              </a:rPr>
              <a:t>m</a:t>
            </a:r>
            <a:endParaRPr lang="ko-KR" altLang="en-US" sz="13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456531" y="4336865"/>
            <a:ext cx="1219900" cy="2527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00" dirty="0" smtClean="0">
                <a:latin typeface="Times New Roman" pitchFamily="18" charset="0"/>
                <a:cs typeface="Times New Roman" pitchFamily="18" charset="0"/>
              </a:rPr>
              <a:t>0 nm</a:t>
            </a:r>
            <a:endParaRPr lang="ko-KR" altLang="en-US" sz="13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95536" y="2348880"/>
            <a:ext cx="1219900" cy="2527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00" dirty="0" smtClean="0">
                <a:latin typeface="Times New Roman" pitchFamily="18" charset="0"/>
                <a:cs typeface="Times New Roman" pitchFamily="18" charset="0"/>
              </a:rPr>
              <a:t>115 nm</a:t>
            </a:r>
            <a:endParaRPr lang="ko-KR" altLang="en-US" sz="13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 rot="16200000">
            <a:off x="3811140" y="3728514"/>
            <a:ext cx="26935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Height</a:t>
            </a:r>
            <a:endParaRPr lang="ko-KR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5364088" y="5353471"/>
            <a:ext cx="30963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Scanned region</a:t>
            </a:r>
            <a:endParaRPr lang="ko-KR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95536" y="657563"/>
            <a:ext cx="8424936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500" b="1" dirty="0" smtClean="0">
                <a:latin typeface="Times New Roman" pitchFamily="18" charset="0"/>
                <a:cs typeface="Times New Roman" pitchFamily="18" charset="0"/>
              </a:rPr>
              <a:t>Figure S5. </a:t>
            </a:r>
            <a:r>
              <a:rPr lang="en-US" altLang="ko-KR" sz="1500" dirty="0" smtClean="0">
                <a:latin typeface="Times New Roman" pitchFamily="18" charset="0"/>
                <a:cs typeface="Times New Roman" pitchFamily="18" charset="0"/>
              </a:rPr>
              <a:t>Hydrodynamic size distribution of </a:t>
            </a:r>
            <a:r>
              <a:rPr lang="en-US" altLang="ko-K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duct of the laccase-catalyzed polymerization of 2,7-DHN</a:t>
            </a:r>
            <a:r>
              <a:rPr lang="en-US" altLang="ko-KR" sz="1500" dirty="0" smtClean="0">
                <a:latin typeface="Times New Roman" pitchFamily="18" charset="0"/>
                <a:cs typeface="Times New Roman" pitchFamily="18" charset="0"/>
              </a:rPr>
              <a:t>. </a:t>
            </a:r>
            <a:endParaRPr lang="ko-KR" altLang="en-US" sz="15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5" name="개체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51991899"/>
              </p:ext>
            </p:extLst>
          </p:nvPr>
        </p:nvGraphicFramePr>
        <p:xfrm>
          <a:off x="1691680" y="1124744"/>
          <a:ext cx="6120680" cy="48245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98" name="SPW 10.0 Graph" r:id="rId3" imgW="5532840" imgH="4329360" progId="SigmaPlotGraphicObject.9">
                  <p:embed/>
                </p:oleObj>
              </mc:Choice>
              <mc:Fallback>
                <p:oleObj name="SPW 10.0 Graph" r:id="rId3" imgW="5532840" imgH="4329360" progId="SigmaPlotGraphicObject.9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691680" y="1124744"/>
                        <a:ext cx="6120680" cy="482453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4967064" y="1772816"/>
            <a:ext cx="230425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verage diameter – 35.8 </a:t>
            </a:r>
            <a:r>
              <a:rPr lang="el-GR" altLang="ko-KR" sz="1200" b="1" dirty="0" smtClean="0"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μ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  <a:p>
            <a:endParaRPr lang="en-US" altLang="ko-KR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lydispersity index – 1.507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5675434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oup 30"/>
          <p:cNvGraphicFramePr>
            <a:graphicFrameLocks noGrp="1"/>
          </p:cNvGraphicFramePr>
          <p:nvPr/>
        </p:nvGraphicFramePr>
        <p:xfrm>
          <a:off x="395536" y="1268760"/>
          <a:ext cx="8352927" cy="1166880"/>
        </p:xfrm>
        <a:graphic>
          <a:graphicData uri="http://schemas.openxmlformats.org/drawingml/2006/table">
            <a:tbl>
              <a:tblPr/>
              <a:tblGrid>
                <a:gridCol w="868823"/>
                <a:gridCol w="1716174"/>
                <a:gridCol w="1648452"/>
                <a:gridCol w="1947419"/>
                <a:gridCol w="2172059"/>
              </a:tblGrid>
              <a:tr h="244827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ko-KR" altLang="ko-KR" sz="12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굴림" charset="-127"/>
                        <a:cs typeface="Times New Roman" pitchFamily="18" charset="0"/>
                      </a:endParaRP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en-US" altLang="ko-KR" sz="13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굴림" charset="-127"/>
                        <a:cs typeface="Times New Roman" pitchFamily="18" charset="0"/>
                      </a:endParaRP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ko-KR" sz="13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굴림" charset="-127"/>
                          <a:cs typeface="Times New Roman" pitchFamily="18" charset="0"/>
                        </a:rPr>
                        <a:t>Theoretical m/z</a:t>
                      </a:r>
                      <a:endParaRPr kumimoji="1" lang="en-US" altLang="ko-KR" sz="1300" b="1" i="0" u="none" strike="noStrike" cap="none" normalizeH="0" baseline="3000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굴림" charset="-127"/>
                        <a:cs typeface="Times New Roman" pitchFamily="18" charset="0"/>
                      </a:endParaRP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ko-KR" sz="13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굴림" charset="-127"/>
                          <a:cs typeface="Times New Roman" pitchFamily="18" charset="0"/>
                        </a:rPr>
                        <a:t>Experimental m/z</a:t>
                      </a:r>
                      <a:endParaRPr kumimoji="1" lang="en-US" altLang="ko-KR" sz="1300" b="1" i="0" u="none" strike="noStrike" cap="none" normalizeH="0" baseline="3000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굴림" charset="-127"/>
                        <a:cs typeface="Times New Roman" pitchFamily="18" charset="0"/>
                      </a:endParaRP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ko-KR" sz="13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굴림" charset="-127"/>
                          <a:cs typeface="Times New Roman" pitchFamily="18" charset="0"/>
                        </a:rPr>
                        <a:t>CID MS/MS of  m/z</a:t>
                      </a:r>
                      <a:endParaRPr kumimoji="1" lang="en-US" altLang="ko-KR" sz="1300" b="1" i="0" u="none" strike="noStrike" cap="none" normalizeH="0" baseline="3000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굴림" charset="-127"/>
                        <a:cs typeface="Times New Roman" pitchFamily="18" charset="0"/>
                      </a:endParaRP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4827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ko-KR" sz="13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굴림" charset="-127"/>
                          <a:cs typeface="Times New Roman" pitchFamily="18" charset="0"/>
                        </a:rPr>
                        <a:t>Standard [M - H]</a:t>
                      </a:r>
                      <a:r>
                        <a:rPr kumimoji="1" lang="en-US" altLang="ko-KR" sz="13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굴림" charset="-127"/>
                          <a:cs typeface="Times New Roman" pitchFamily="18" charset="0"/>
                        </a:rPr>
                        <a:t>-</a:t>
                      </a:r>
                      <a:endParaRPr kumimoji="1" lang="ko-KR" altLang="ko-KR" sz="1300" b="1" i="0" u="none" strike="noStrike" cap="none" normalizeH="0" baseline="3000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굴림" charset="-127"/>
                        <a:cs typeface="Times New Roman" pitchFamily="18" charset="0"/>
                      </a:endParaRP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alpha val="21176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ko-KR" sz="13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굴림" charset="-127"/>
                          <a:cs typeface="Times New Roman" pitchFamily="18" charset="0"/>
                        </a:rPr>
                        <a:t>159.1</a:t>
                      </a: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alpha val="21176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ko-KR" sz="13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굴림" charset="-127"/>
                          <a:cs typeface="Times New Roman" pitchFamily="18" charset="0"/>
                        </a:rPr>
                        <a:t>158.9</a:t>
                      </a: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alpha val="21176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ko-KR" sz="13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굴림" charset="-127"/>
                          <a:cs typeface="Times New Roman" pitchFamily="18" charset="0"/>
                        </a:rPr>
                        <a:t>130.1; 102.5</a:t>
                      </a: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alpha val="21176"/>
                      </a:schemeClr>
                    </a:solidFill>
                  </a:tcPr>
                </a:tc>
              </a:tr>
              <a:tr h="244827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ko-KR" sz="13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굴림" charset="-127"/>
                          <a:cs typeface="Times New Roman" pitchFamily="18" charset="0"/>
                        </a:rPr>
                        <a:t>[M + M – H]</a:t>
                      </a:r>
                      <a:r>
                        <a:rPr kumimoji="1" lang="en-US" altLang="ko-KR" sz="13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굴림" charset="-127"/>
                          <a:cs typeface="Times New Roman" pitchFamily="18" charset="0"/>
                        </a:rPr>
                        <a:t>-</a:t>
                      </a: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ko-KR" sz="13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굴림" charset="-127"/>
                          <a:cs typeface="Times New Roman" pitchFamily="18" charset="0"/>
                        </a:rPr>
                        <a:t>317.1</a:t>
                      </a: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ko-KR" sz="13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굴림" charset="-127"/>
                          <a:cs typeface="Times New Roman" pitchFamily="18" charset="0"/>
                        </a:rPr>
                        <a:t>317.0</a:t>
                      </a: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ko-KR" sz="13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굴림" charset="-127"/>
                          <a:cs typeface="Times New Roman" pitchFamily="18" charset="0"/>
                        </a:rPr>
                        <a:t>157.8; 130.1</a:t>
                      </a: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4827">
                <a:tc gridSpan="2"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ko-KR" sz="13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굴림" charset="-127"/>
                          <a:cs typeface="Times New Roman" pitchFamily="18" charset="0"/>
                        </a:rPr>
                        <a:t>[M + M + M – H]</a:t>
                      </a:r>
                      <a:r>
                        <a:rPr kumimoji="1" lang="en-US" altLang="ko-KR" sz="13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굴림" charset="-127"/>
                          <a:cs typeface="Times New Roman" pitchFamily="18" charset="0"/>
                        </a:rPr>
                        <a:t>-</a:t>
                      </a: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ko-KR" sz="13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굴림" charset="-127"/>
                          <a:cs typeface="Times New Roman" pitchFamily="18" charset="0"/>
                        </a:rPr>
                        <a:t>475.1</a:t>
                      </a: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ko-KR" sz="13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굴림" charset="-127"/>
                          <a:cs typeface="Times New Roman" pitchFamily="18" charset="0"/>
                        </a:rPr>
                        <a:t>475.2</a:t>
                      </a: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ko-KR" sz="13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굴림" charset="-127"/>
                          <a:cs typeface="Times New Roman" pitchFamily="18" charset="0"/>
                        </a:rPr>
                        <a:t>158.1; 129.7</a:t>
                      </a: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23528" y="583132"/>
            <a:ext cx="856895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Table S1. 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Comparison of relevant collision-induced dissociation (CID) MS/MS peaks of homo-oligomers formed in </a:t>
            </a:r>
            <a:r>
              <a:rPr lang="en-US" altLang="ko-KR" sz="1400" i="1" dirty="0" smtClean="0">
                <a:latin typeface="Times New Roman" pitchFamily="18" charset="0"/>
                <a:cs typeface="Times New Roman" pitchFamily="18" charset="0"/>
              </a:rPr>
              <a:t>in vitro 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laccase-mediated polymerization of 2,7-DHN with those of standard 2,7-DHN. </a:t>
            </a:r>
            <a:endParaRPr lang="ko-KR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51520" y="692696"/>
            <a:ext cx="8424936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500" b="1" dirty="0" smtClean="0">
                <a:latin typeface="Times New Roman" pitchFamily="18" charset="0"/>
                <a:cs typeface="Times New Roman" pitchFamily="18" charset="0"/>
              </a:rPr>
              <a:t>Table S2. </a:t>
            </a:r>
            <a:r>
              <a:rPr lang="en-US" altLang="ko-KR" sz="1500" dirty="0" smtClean="0">
                <a:latin typeface="Times New Roman" pitchFamily="18" charset="0"/>
                <a:cs typeface="Times New Roman" pitchFamily="18" charset="0"/>
              </a:rPr>
              <a:t>Time course of changes in coating thickness of 2,7-DHN coated PET film.</a:t>
            </a:r>
          </a:p>
          <a:p>
            <a:pPr algn="just"/>
            <a:endParaRPr lang="en-US" altLang="ko-KR" sz="15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US" altLang="ko-KR" sz="1500" dirty="0" smtClean="0">
                <a:latin typeface="Times New Roman" pitchFamily="18" charset="0"/>
                <a:cs typeface="Times New Roman" pitchFamily="18" charset="0"/>
              </a:rPr>
              <a:t>     </a:t>
            </a:r>
            <a:endParaRPr lang="ko-KR" altLang="en-US" sz="15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6" name="Group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60120371"/>
              </p:ext>
            </p:extLst>
          </p:nvPr>
        </p:nvGraphicFramePr>
        <p:xfrm>
          <a:off x="395537" y="1329704"/>
          <a:ext cx="5256583" cy="1797180"/>
        </p:xfrm>
        <a:graphic>
          <a:graphicData uri="http://schemas.openxmlformats.org/drawingml/2006/table">
            <a:tbl>
              <a:tblPr/>
              <a:tblGrid>
                <a:gridCol w="2061405"/>
                <a:gridCol w="3195178"/>
              </a:tblGrid>
              <a:tr h="5643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ko-KR" altLang="en-US" sz="14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맑은 고딕"/>
                        <a:cs typeface="맑은 고딕"/>
                      </a:endParaRP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ko-KR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맑은 고딕"/>
                          <a:cs typeface="맑은 고딕"/>
                        </a:rPr>
                        <a:t>Thickness (nm)</a:t>
                      </a: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0011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ko-KR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맑은 고딕"/>
                          <a:cs typeface="맑은 고딕"/>
                        </a:rPr>
                        <a:t>7 h</a:t>
                      </a: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ko-KR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맑은 고딕"/>
                          <a:cs typeface="맑은 고딕"/>
                        </a:rPr>
                        <a:t>0</a:t>
                      </a:r>
                      <a:endParaRPr kumimoji="0" lang="en-US" altLang="ko-KR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08886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ko-KR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맑은 고딕"/>
                          <a:cs typeface="맑은 고딕"/>
                        </a:rPr>
                        <a:t>15 h</a:t>
                      </a: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  <a:defRPr/>
                      </a:pPr>
                      <a:r>
                        <a:rPr kumimoji="0" lang="en-US" altLang="ko-KR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75 ± 39</a:t>
                      </a: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6739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ko-KR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맑은 고딕"/>
                          <a:cs typeface="맑은 고딕"/>
                        </a:rPr>
                        <a:t>26 h</a:t>
                      </a: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ko-KR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90 </a:t>
                      </a:r>
                      <a:r>
                        <a:rPr kumimoji="0" lang="en-US" altLang="ko-KR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± 35</a:t>
                      </a:r>
                      <a:endParaRPr kumimoji="0" lang="en-US" altLang="ko-KR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맑은 고딕"/>
                        <a:cs typeface="Times New Roman" pitchFamily="18" charset="0"/>
                      </a:endParaRP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8860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ko-KR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맑은 고딕"/>
                          <a:cs typeface="맑은 고딕"/>
                        </a:rPr>
                        <a:t>72 h</a:t>
                      </a: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ko-KR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맑은 고딕"/>
                          <a:cs typeface="맑은 고딕"/>
                        </a:rPr>
                        <a:t>85 </a:t>
                      </a:r>
                      <a:r>
                        <a:rPr kumimoji="0" lang="en-US" altLang="ko-KR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± 48</a:t>
                      </a: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1601567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oup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66443658"/>
              </p:ext>
            </p:extLst>
          </p:nvPr>
        </p:nvGraphicFramePr>
        <p:xfrm>
          <a:off x="395537" y="1329704"/>
          <a:ext cx="5976663" cy="1227840"/>
        </p:xfrm>
        <a:graphic>
          <a:graphicData uri="http://schemas.openxmlformats.org/drawingml/2006/table">
            <a:tbl>
              <a:tblPr/>
              <a:tblGrid>
                <a:gridCol w="1854825"/>
                <a:gridCol w="1717432"/>
                <a:gridCol w="2404406"/>
              </a:tblGrid>
              <a:tr h="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endParaRPr kumimoji="0" lang="ko-KR" altLang="en-US" sz="14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맑은 고딕"/>
                        <a:cs typeface="맑은 고딕"/>
                      </a:endParaRP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ko-KR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맑은 고딕"/>
                          <a:cs typeface="맑은 고딕"/>
                        </a:rPr>
                        <a:t>Untreated</a:t>
                      </a: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ko-KR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맑은 고딕"/>
                          <a:cs typeface="맑은 고딕"/>
                        </a:rPr>
                        <a:t>DHN-coated</a:t>
                      </a: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ko-KR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맑은 고딕"/>
                          <a:cs typeface="맑은 고딕"/>
                        </a:rPr>
                        <a:t>Casted  polypropylene</a:t>
                      </a: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ko-KR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맑은 고딕"/>
                          <a:cs typeface="맑은 고딕"/>
                        </a:rPr>
                        <a:t>91.5 </a:t>
                      </a:r>
                      <a:r>
                        <a:rPr kumimoji="0" lang="en-US" altLang="ko-KR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± 1.0</a:t>
                      </a: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ko-KR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맑은 고딕"/>
                          <a:cs typeface="맑은 고딕"/>
                        </a:rPr>
                        <a:t>101.5 </a:t>
                      </a:r>
                      <a:r>
                        <a:rPr kumimoji="0" lang="en-US" altLang="ko-KR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± 5.3</a:t>
                      </a: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ko-KR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맑은 고딕"/>
                          <a:cs typeface="맑은 고딕"/>
                        </a:rPr>
                        <a:t>Nylon</a:t>
                      </a: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ko-KR" sz="14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60.8 ± 2.8</a:t>
                      </a: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ko-KR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73.2 ± 1.2</a:t>
                      </a: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ko-KR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맑은 고딕"/>
                          <a:cs typeface="맑은 고딕"/>
                        </a:rPr>
                        <a:t>PET</a:t>
                      </a: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ko-KR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맑은 고딕"/>
                          <a:cs typeface="맑은 고딕"/>
                        </a:rPr>
                        <a:t>74.2 </a:t>
                      </a:r>
                      <a:r>
                        <a:rPr kumimoji="0" lang="en-US" altLang="ko-KR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± 0.4</a:t>
                      </a: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1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ko-KR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맑은 고딕"/>
                          <a:cs typeface="맑은 고딕"/>
                        </a:rPr>
                        <a:t>63.7 </a:t>
                      </a:r>
                      <a:r>
                        <a:rPr kumimoji="0" lang="en-US" altLang="ko-KR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± 1.1</a:t>
                      </a:r>
                    </a:p>
                  </a:txBody>
                  <a:tcPr marL="90000" marR="90000" marT="46800" marB="4680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23528" y="583132"/>
            <a:ext cx="856895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Table S3. 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Water contact angle of  </a:t>
            </a:r>
            <a:r>
              <a:rPr lang="en-US" altLang="ko-KR" sz="1400" smtClean="0">
                <a:latin typeface="Times New Roman" pitchFamily="18" charset="0"/>
                <a:cs typeface="Times New Roman" pitchFamily="18" charset="0"/>
              </a:rPr>
              <a:t>2,7-DHN </a:t>
            </a:r>
            <a:r>
              <a:rPr lang="en-US" altLang="ko-KR" sz="1400" smtClean="0">
                <a:latin typeface="Times New Roman" pitchFamily="18" charset="0"/>
                <a:cs typeface="Times New Roman" pitchFamily="18" charset="0"/>
              </a:rPr>
              <a:t>coated 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films. Average and standard deviations of six-measurement were shown.  </a:t>
            </a:r>
            <a:endParaRPr lang="ko-KR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802</TotalTime>
  <Words>423</Words>
  <Application>Microsoft Office PowerPoint</Application>
  <PresentationFormat>화면 슬라이드 쇼(4:3)</PresentationFormat>
  <Paragraphs>82</Paragraphs>
  <Slides>10</Slides>
  <Notes>0</Notes>
  <HiddenSlides>0</HiddenSlides>
  <MMClips>0</MMClips>
  <ScaleCrop>false</ScaleCrop>
  <HeadingPairs>
    <vt:vector size="6" baseType="variant"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10</vt:i4>
      </vt:variant>
    </vt:vector>
  </HeadingPairs>
  <TitlesOfParts>
    <vt:vector size="12" baseType="lpstr">
      <vt:lpstr>Office 테마</vt:lpstr>
      <vt:lpstr>SPW 10.0 Graph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owner</dc:creator>
  <cp:lastModifiedBy>user</cp:lastModifiedBy>
  <cp:revision>90</cp:revision>
  <dcterms:created xsi:type="dcterms:W3CDTF">2013-08-08T13:36:26Z</dcterms:created>
  <dcterms:modified xsi:type="dcterms:W3CDTF">2015-11-27T00:48:09Z</dcterms:modified>
</cp:coreProperties>
</file>